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  <p:sldId id="256" r:id="rId3"/>
    <p:sldId id="257" r:id="rId4"/>
    <p:sldId id="258" r:id="rId5"/>
    <p:sldId id="259" r:id="rId6"/>
    <p:sldId id="261" r:id="rId7"/>
    <p:sldId id="260" r:id="rId8"/>
    <p:sldId id="262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158"/>
    <p:restoredTop sz="94694"/>
  </p:normalViewPr>
  <p:slideViewPr>
    <p:cSldViewPr snapToGrid="0" snapToObjects="1">
      <p:cViewPr varScale="1">
        <p:scale>
          <a:sx n="133" d="100"/>
          <a:sy n="133" d="100"/>
        </p:scale>
        <p:origin x="120" y="52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6CECC5-8500-C144-AF1A-D622430527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47E1050-07DE-2944-A1FA-E557BD66E5D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14435-1863-704D-852C-94D1B3460F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3579-C8E5-5E4B-B2B1-518275B15280}" type="datetimeFigureOut">
              <a:rPr lang="en-US" smtClean="0"/>
              <a:t>9/1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8B7423-D695-F942-A056-EC0E7BDEBE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548F51-9881-574F-B6AE-1B792B88F6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82940-F82F-2642-ABA9-880CE4C75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7130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F6BFCA-71A0-4F48-9F1D-3377C9CE93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3D2021-61BD-C346-8522-C34B4D1E3C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F8A635-CBC3-4F4D-80BC-DD9DD10EB1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3579-C8E5-5E4B-B2B1-518275B15280}" type="datetimeFigureOut">
              <a:rPr lang="en-US" smtClean="0"/>
              <a:t>9/1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B9C3C7-D8D5-1F4F-9AB6-45F5C2098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A820AF-D16E-D145-AD46-6815B6725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82940-F82F-2642-ABA9-880CE4C75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9837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9D3175D-259A-2144-B2B4-2AEC94E1607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2CA4014-23D5-204E-BE7E-0B9E87D025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642C6B-B258-DD45-8867-CF1D2E3B42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3579-C8E5-5E4B-B2B1-518275B15280}" type="datetimeFigureOut">
              <a:rPr lang="en-US" smtClean="0"/>
              <a:t>9/1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D68D6A-D7BE-9748-9514-7C3A025F67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D4AC1F-E5F9-6A4F-B16E-BA670374B7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82940-F82F-2642-ABA9-880CE4C75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0811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EF3176-A517-6246-9A5A-A24E05F197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DA5315-95E6-354F-AF07-8FD52259734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15E204-D429-3C4D-A2EE-5C79D0B967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3579-C8E5-5E4B-B2B1-518275B15280}" type="datetimeFigureOut">
              <a:rPr lang="en-US" smtClean="0"/>
              <a:t>9/1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A5CC33-890F-C347-AE4A-4B75B51024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0A970C-F8EC-284D-9076-B717ADC8C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82940-F82F-2642-ABA9-880CE4C75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69049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5EB493-9B87-764B-8827-2CEABAE621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E611CD-503B-B043-B35C-122CFE7B73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E43176-00B6-794C-A2F2-3BE23FE552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3579-C8E5-5E4B-B2B1-518275B15280}" type="datetimeFigureOut">
              <a:rPr lang="en-US" smtClean="0"/>
              <a:t>9/1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146E57-F12C-4D40-9490-CAFAEFC9A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12F42D-7458-9342-959D-60F75672A3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82940-F82F-2642-ABA9-880CE4C75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00888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A51145-FEC1-474F-A307-9812E541C3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716507-A372-9841-80A7-B0B0B919C33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B2D3776-27ED-DC4D-96EC-B5A3DD1272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FC949C-2AE2-704A-B2FC-B787D2A0C0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3579-C8E5-5E4B-B2B1-518275B15280}" type="datetimeFigureOut">
              <a:rPr lang="en-US" smtClean="0"/>
              <a:t>9/1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E3B445-2382-A146-B47B-325BA553FE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2DA5F5-62A0-B149-9733-6CEA51C479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82940-F82F-2642-ABA9-880CE4C75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7099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7CB365-D553-1A4F-99A8-389A1DBEE1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F5F35A-9312-4448-8402-A5136194DA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D427A2-3FD0-1048-A824-6F757E46DF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681A060-D579-3C43-904A-C78D7D78108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A717FE4-274B-1748-92C3-94541EC0652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C5F26C9-8BA7-EB46-9692-07DAC86A70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3579-C8E5-5E4B-B2B1-518275B15280}" type="datetimeFigureOut">
              <a:rPr lang="en-US" smtClean="0"/>
              <a:t>9/15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D95D0B8-0819-F94A-9B41-C67DF75B1A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583E0C1-6C5B-034B-85E8-48B3BCA6F7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82940-F82F-2642-ABA9-880CE4C75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6157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E4E74F-9A41-BD4A-9F28-DC95C459D1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A0E71C1-BA90-DC4B-8F86-ECF1755273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3579-C8E5-5E4B-B2B1-518275B15280}" type="datetimeFigureOut">
              <a:rPr lang="en-US" smtClean="0"/>
              <a:t>9/15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DE26159-31F8-7843-9D1E-162DA1A100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015DCF9-1445-A540-990B-B681D8BB24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82940-F82F-2642-ABA9-880CE4C75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3526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C8A6376-2ED6-674B-B9FE-FF45696B1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3579-C8E5-5E4B-B2B1-518275B15280}" type="datetimeFigureOut">
              <a:rPr lang="en-US" smtClean="0"/>
              <a:t>9/15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AEC3A8F-9E12-254F-8C97-7DEE2B465E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0ECDE39-0D55-AD42-A88E-361EA75970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82940-F82F-2642-ABA9-880CE4C75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232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631E16-BF73-9E48-A500-4B3037723A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FE452E-F6D1-5448-842E-E70D795258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5A73704-B99C-C149-8093-B98C727C61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54F2BB-9D66-C147-A345-B54F3F461E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3579-C8E5-5E4B-B2B1-518275B15280}" type="datetimeFigureOut">
              <a:rPr lang="en-US" smtClean="0"/>
              <a:t>9/1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2B3964-B7BF-464C-B193-0E7723C983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6AFC77-C1AB-9D44-A6BF-ACCC9F5F38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82940-F82F-2642-ABA9-880CE4C75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7866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32D639-C03B-3D4D-9756-AA38D4E9B5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A8B97B3-1E31-DA45-AAC0-3FA7D107E5A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049F78-CF45-EE44-ABAA-900D73CA07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9C4B07-C137-FC4E-9A46-72613D8BDB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3579-C8E5-5E4B-B2B1-518275B15280}" type="datetimeFigureOut">
              <a:rPr lang="en-US" smtClean="0"/>
              <a:t>9/1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F693E3-94E9-4245-AA7E-FEE56615FF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C2FCFD-19B0-2440-8788-450B8C91D6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82940-F82F-2642-ABA9-880CE4C75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62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229C176-62E6-6C4C-97F5-72C7938B1F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7C8690-11DF-A74F-A93C-815BBDED8B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797CBC-873E-D843-B572-F119202B34C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683579-C8E5-5E4B-B2B1-518275B15280}" type="datetimeFigureOut">
              <a:rPr lang="en-US" smtClean="0"/>
              <a:t>9/1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381732-1867-7044-B249-01A5FC5FFDF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130A65-5EC2-8F48-85A4-84CC47894D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482940-F82F-2642-ABA9-880CE4C75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527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400" b="1" dirty="0" smtClean="0"/>
              <a:t>S2 Fig</a:t>
            </a:r>
            <a:r>
              <a:rPr lang="en-US" sz="2400" b="1" dirty="0"/>
              <a:t>. </a:t>
            </a:r>
            <a:r>
              <a:rPr lang="en-US" sz="2400" dirty="0" err="1" smtClean="0"/>
              <a:t>Powerpoint</a:t>
            </a:r>
            <a:r>
              <a:rPr lang="en-US" sz="2400" dirty="0" smtClean="0"/>
              <a:t> </a:t>
            </a:r>
            <a:r>
              <a:rPr lang="en-US" sz="2400" dirty="0"/>
              <a:t>summary of genetic content of genomic islands that were lost and gained within HC20_373.</a:t>
            </a:r>
            <a:endParaRPr lang="en-GB" sz="2400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2000" dirty="0" smtClean="0"/>
              <a:t>S2A Fig. </a:t>
            </a:r>
            <a:r>
              <a:rPr lang="en-US" sz="2000" dirty="0"/>
              <a:t>Deletions of SPI regions from laboratory and ATCC14028s </a:t>
            </a:r>
            <a:r>
              <a:rPr lang="en-US" sz="2000" dirty="0" smtClean="0"/>
              <a:t>isolates: Slide </a:t>
            </a:r>
            <a:r>
              <a:rPr lang="en-US" sz="2000" dirty="0"/>
              <a:t>2. </a:t>
            </a:r>
            <a:endParaRPr lang="en-US" sz="2000" dirty="0" smtClean="0"/>
          </a:p>
          <a:p>
            <a:r>
              <a:rPr lang="en-US" sz="2000" dirty="0" smtClean="0"/>
              <a:t>S2B Fig. </a:t>
            </a:r>
            <a:r>
              <a:rPr lang="en-US" sz="2000" dirty="0"/>
              <a:t>Deletions of various chromosomal regions from laboratory and </a:t>
            </a:r>
            <a:r>
              <a:rPr lang="en-US" sz="2000" dirty="0" smtClean="0"/>
              <a:t>ATCC14028s isolates: </a:t>
            </a:r>
            <a:r>
              <a:rPr lang="en-US" sz="2000" dirty="0"/>
              <a:t>Slide </a:t>
            </a:r>
            <a:r>
              <a:rPr lang="en-US" sz="2000" dirty="0" smtClean="0"/>
              <a:t>3.</a:t>
            </a:r>
          </a:p>
          <a:p>
            <a:pPr marL="230400" indent="-230400"/>
            <a:r>
              <a:rPr lang="en-US" sz="2000" dirty="0" smtClean="0"/>
              <a:t>S2C Fig. </a:t>
            </a:r>
            <a:r>
              <a:rPr lang="en-US" sz="2000" dirty="0" smtClean="0"/>
              <a:t>Loss </a:t>
            </a:r>
            <a:r>
              <a:rPr lang="en-US" sz="2000" dirty="0"/>
              <a:t>of </a:t>
            </a:r>
            <a:r>
              <a:rPr lang="en-US" sz="2000" dirty="0" smtClean="0"/>
              <a:t>lysogenic bacteriophages Gifsy-1 or Gifsy-3 from </a:t>
            </a:r>
            <a:r>
              <a:rPr lang="en-US" sz="2000" dirty="0"/>
              <a:t>natural </a:t>
            </a:r>
            <a:r>
              <a:rPr lang="en-US" sz="2000" dirty="0" smtClean="0"/>
              <a:t>isolates and ATCC14028s : Slide 4</a:t>
            </a:r>
          </a:p>
          <a:p>
            <a:r>
              <a:rPr lang="en-US" sz="2000" dirty="0" smtClean="0"/>
              <a:t>S2D Fig. </a:t>
            </a:r>
            <a:r>
              <a:rPr lang="en-US" sz="2000" dirty="0"/>
              <a:t>Loss of </a:t>
            </a:r>
            <a:r>
              <a:rPr lang="en-US" sz="2000" dirty="0" err="1"/>
              <a:t>pSV</a:t>
            </a:r>
            <a:r>
              <a:rPr lang="en-US" sz="2000" dirty="0"/>
              <a:t> </a:t>
            </a:r>
            <a:r>
              <a:rPr lang="en-US" sz="2000" dirty="0" err="1"/>
              <a:t>IncFII</a:t>
            </a:r>
            <a:r>
              <a:rPr lang="en-US" sz="2000" dirty="0"/>
              <a:t> (S) Virulence plasmid from ATCC14028s and natural </a:t>
            </a:r>
            <a:r>
              <a:rPr lang="en-US" sz="2000" dirty="0" smtClean="0"/>
              <a:t>isolates: Slide 5</a:t>
            </a:r>
          </a:p>
          <a:p>
            <a:r>
              <a:rPr lang="en-US" sz="2000" dirty="0" smtClean="0"/>
              <a:t>S2E Fig. </a:t>
            </a:r>
            <a:r>
              <a:rPr lang="en-US" sz="2000" dirty="0" smtClean="0"/>
              <a:t>Bacteriophages which lysogenized natural isolates: Slide 6.</a:t>
            </a:r>
          </a:p>
          <a:p>
            <a:r>
              <a:rPr lang="en-US" sz="2000" dirty="0" smtClean="0"/>
              <a:t>S2F Fig. </a:t>
            </a:r>
            <a:r>
              <a:rPr lang="en-US" sz="2000" dirty="0"/>
              <a:t>Plasmids acquired by natural </a:t>
            </a:r>
            <a:r>
              <a:rPr lang="en-US" sz="2000" dirty="0" smtClean="0"/>
              <a:t>isolates: Slide 7.</a:t>
            </a:r>
          </a:p>
          <a:p>
            <a:r>
              <a:rPr lang="en-US" sz="2000" dirty="0" smtClean="0"/>
              <a:t>S2G Fig. </a:t>
            </a:r>
            <a:r>
              <a:rPr lang="en-US" sz="2000" dirty="0" smtClean="0"/>
              <a:t>IncI1 </a:t>
            </a:r>
            <a:r>
              <a:rPr lang="en-US" sz="2000" dirty="0"/>
              <a:t>plasmids acquired by natural isolates and lab </a:t>
            </a:r>
            <a:r>
              <a:rPr lang="en-US" sz="2000" dirty="0" smtClean="0"/>
              <a:t>infections: Slide 8.</a:t>
            </a:r>
          </a:p>
          <a:p>
            <a:endParaRPr lang="en-US" sz="2000" dirty="0"/>
          </a:p>
          <a:p>
            <a:endParaRPr lang="en-US" sz="2000" dirty="0"/>
          </a:p>
          <a:p>
            <a:endParaRPr lang="en-US" sz="2000" dirty="0" smtClean="0"/>
          </a:p>
          <a:p>
            <a:endParaRPr lang="en-US" sz="2000" dirty="0"/>
          </a:p>
          <a:p>
            <a:endParaRPr lang="en-US" sz="2000" dirty="0"/>
          </a:p>
          <a:p>
            <a:endParaRPr lang="en-US" sz="2000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465433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7DDC72CD-FCAC-E844-BD86-5D3E5B771E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3300" y="1303196"/>
            <a:ext cx="10185400" cy="515475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C2282A0-5FDD-9D40-BD94-1368B045A4BA}"/>
              </a:ext>
            </a:extLst>
          </p:cNvPr>
          <p:cNvSpPr txBox="1"/>
          <p:nvPr/>
        </p:nvSpPr>
        <p:spPr>
          <a:xfrm>
            <a:off x="1689315" y="665832"/>
            <a:ext cx="73374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2A Fig</a:t>
            </a:r>
            <a:r>
              <a:rPr lang="en-US" dirty="0" smtClean="0"/>
              <a:t>. </a:t>
            </a:r>
            <a:r>
              <a:rPr lang="en-US" dirty="0" smtClean="0"/>
              <a:t>Deletions </a:t>
            </a:r>
            <a:r>
              <a:rPr lang="en-US" dirty="0"/>
              <a:t>of SPI regions from laboratory and ATCC14028s </a:t>
            </a:r>
            <a:r>
              <a:rPr lang="en-US" dirty="0" smtClean="0"/>
              <a:t>isolates</a:t>
            </a:r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A7003CA-B93E-0445-B4E2-E4E00D160C82}"/>
              </a:ext>
            </a:extLst>
          </p:cNvPr>
          <p:cNvSpPr txBox="1"/>
          <p:nvPr/>
        </p:nvSpPr>
        <p:spPr>
          <a:xfrm>
            <a:off x="3077300" y="1482965"/>
            <a:ext cx="4161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/>
              <a:t>pipD</a:t>
            </a:r>
            <a:r>
              <a:rPr lang="en-US" sz="800" dirty="0"/>
              <a:t>’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8229DE7-34F2-9242-91D1-228D04542B86}"/>
              </a:ext>
            </a:extLst>
          </p:cNvPr>
          <p:cNvSpPr txBox="1"/>
          <p:nvPr/>
        </p:nvSpPr>
        <p:spPr>
          <a:xfrm>
            <a:off x="3569678" y="1781907"/>
            <a:ext cx="4161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/>
              <a:t>pagC</a:t>
            </a:r>
            <a:endParaRPr lang="en-US" sz="8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A31CE3E-EF22-DB42-B584-EE780B710C5C}"/>
              </a:ext>
            </a:extLst>
          </p:cNvPr>
          <p:cNvSpPr txBox="1"/>
          <p:nvPr/>
        </p:nvSpPr>
        <p:spPr>
          <a:xfrm>
            <a:off x="2661131" y="1787764"/>
            <a:ext cx="4161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/>
              <a:t>envF</a:t>
            </a:r>
            <a:endParaRPr lang="en-US" sz="800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82071EB5-060C-8944-BF08-3EAFF90BD793}"/>
              </a:ext>
            </a:extLst>
          </p:cNvPr>
          <p:cNvSpPr/>
          <p:nvPr/>
        </p:nvSpPr>
        <p:spPr>
          <a:xfrm>
            <a:off x="3094887" y="2305582"/>
            <a:ext cx="240323" cy="45719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710E3F0-2920-C648-A869-2A5D0A49BDC2}"/>
              </a:ext>
            </a:extLst>
          </p:cNvPr>
          <p:cNvSpPr txBox="1"/>
          <p:nvPr/>
        </p:nvSpPr>
        <p:spPr>
          <a:xfrm>
            <a:off x="3001112" y="2203948"/>
            <a:ext cx="4161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/>
              <a:t>ssaD</a:t>
            </a:r>
            <a:endParaRPr lang="en-US" sz="800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4D35F85-71D6-5945-A2EF-C1CDD5516DB5}"/>
              </a:ext>
            </a:extLst>
          </p:cNvPr>
          <p:cNvSpPr/>
          <p:nvPr/>
        </p:nvSpPr>
        <p:spPr>
          <a:xfrm>
            <a:off x="2321140" y="3161366"/>
            <a:ext cx="240323" cy="45719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9D3B2762-FAF1-4E4B-B67A-791C0102D251}"/>
              </a:ext>
            </a:extLst>
          </p:cNvPr>
          <p:cNvSpPr/>
          <p:nvPr/>
        </p:nvSpPr>
        <p:spPr>
          <a:xfrm>
            <a:off x="3575539" y="2299716"/>
            <a:ext cx="46897" cy="45719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5B2E7C96-881B-A24C-A8A8-01A0E32366D6}"/>
              </a:ext>
            </a:extLst>
          </p:cNvPr>
          <p:cNvSpPr/>
          <p:nvPr/>
        </p:nvSpPr>
        <p:spPr>
          <a:xfrm>
            <a:off x="3247287" y="2733482"/>
            <a:ext cx="240323" cy="45719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A10D05F-3B95-0F4E-B1CF-C24D1CD5898A}"/>
              </a:ext>
            </a:extLst>
          </p:cNvPr>
          <p:cNvSpPr txBox="1"/>
          <p:nvPr/>
        </p:nvSpPr>
        <p:spPr>
          <a:xfrm>
            <a:off x="3153512" y="2637714"/>
            <a:ext cx="4161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/>
              <a:t>ssaD</a:t>
            </a:r>
            <a:endParaRPr lang="en-US" sz="8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025EA59-7AEE-594C-9442-094A3B4F932B}"/>
              </a:ext>
            </a:extLst>
          </p:cNvPr>
          <p:cNvSpPr txBox="1"/>
          <p:nvPr/>
        </p:nvSpPr>
        <p:spPr>
          <a:xfrm>
            <a:off x="2250827" y="3065607"/>
            <a:ext cx="4161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/>
              <a:t>ssaD</a:t>
            </a:r>
            <a:endParaRPr lang="en-US" sz="800" dirty="0"/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859435CA-4B9B-D645-AF90-571B58E0121A}"/>
              </a:ext>
            </a:extLst>
          </p:cNvPr>
          <p:cNvGrpSpPr/>
          <p:nvPr/>
        </p:nvGrpSpPr>
        <p:grpSpPr>
          <a:xfrm>
            <a:off x="6922435" y="2639622"/>
            <a:ext cx="825025" cy="223064"/>
            <a:chOff x="6922435" y="2639622"/>
            <a:chExt cx="825025" cy="223064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BC18A957-697A-A344-80BE-9183C953D8AE}"/>
                </a:ext>
              </a:extLst>
            </p:cNvPr>
            <p:cNvGrpSpPr/>
            <p:nvPr/>
          </p:nvGrpSpPr>
          <p:grpSpPr>
            <a:xfrm>
              <a:off x="6922435" y="2641381"/>
              <a:ext cx="416169" cy="215444"/>
              <a:chOff x="8094755" y="2406918"/>
              <a:chExt cx="416169" cy="215444"/>
            </a:xfrm>
          </p:grpSpPr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C54335A7-F35F-F747-8837-0ADD29D394AD}"/>
                  </a:ext>
                </a:extLst>
              </p:cNvPr>
              <p:cNvSpPr/>
              <p:nvPr/>
            </p:nvSpPr>
            <p:spPr>
              <a:xfrm>
                <a:off x="8182679" y="2493147"/>
                <a:ext cx="240323" cy="45719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0F46B69B-3F6A-5D47-98D7-0FBC5824966A}"/>
                  </a:ext>
                </a:extLst>
              </p:cNvPr>
              <p:cNvSpPr txBox="1"/>
              <p:nvPr/>
            </p:nvSpPr>
            <p:spPr>
              <a:xfrm>
                <a:off x="8094755" y="2406918"/>
                <a:ext cx="41616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err="1"/>
                  <a:t>ssaQ</a:t>
                </a:r>
                <a:endParaRPr lang="en-US" sz="800" dirty="0"/>
              </a:p>
            </p:txBody>
          </p: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4DAB1B32-B651-AD4E-8647-47C3B5D60E3C}"/>
                </a:ext>
              </a:extLst>
            </p:cNvPr>
            <p:cNvGrpSpPr/>
            <p:nvPr/>
          </p:nvGrpSpPr>
          <p:grpSpPr>
            <a:xfrm>
              <a:off x="7121741" y="2647242"/>
              <a:ext cx="416169" cy="215444"/>
              <a:chOff x="7121741" y="2647242"/>
              <a:chExt cx="416169" cy="215444"/>
            </a:xfrm>
          </p:grpSpPr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B3551376-7121-CE42-A9ED-C2C22835C7F3}"/>
                  </a:ext>
                </a:extLst>
              </p:cNvPr>
              <p:cNvSpPr/>
              <p:nvPr/>
            </p:nvSpPr>
            <p:spPr>
              <a:xfrm>
                <a:off x="7250682" y="2733470"/>
                <a:ext cx="111382" cy="45719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40B5832F-0172-5346-A6AD-DE647403CF2F}"/>
                  </a:ext>
                </a:extLst>
              </p:cNvPr>
              <p:cNvSpPr txBox="1"/>
              <p:nvPr/>
            </p:nvSpPr>
            <p:spPr>
              <a:xfrm>
                <a:off x="7121741" y="2647242"/>
                <a:ext cx="41616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   R</a:t>
                </a:r>
              </a:p>
            </p:txBody>
          </p: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BF9D63DE-FCA2-4C48-9012-303D5548F5F3}"/>
                </a:ext>
              </a:extLst>
            </p:cNvPr>
            <p:cNvGrpSpPr/>
            <p:nvPr/>
          </p:nvGrpSpPr>
          <p:grpSpPr>
            <a:xfrm>
              <a:off x="7331291" y="2639622"/>
              <a:ext cx="416169" cy="215444"/>
              <a:chOff x="7121741" y="2647242"/>
              <a:chExt cx="416169" cy="215444"/>
            </a:xfrm>
          </p:grpSpPr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76036F86-F9EC-654C-84A6-30D564BF9CE8}"/>
                  </a:ext>
                </a:extLst>
              </p:cNvPr>
              <p:cNvSpPr/>
              <p:nvPr/>
            </p:nvSpPr>
            <p:spPr>
              <a:xfrm>
                <a:off x="7250682" y="2733470"/>
                <a:ext cx="111382" cy="45719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A1895A72-E668-A74D-AF72-1DEFE1E54FD2}"/>
                  </a:ext>
                </a:extLst>
              </p:cNvPr>
              <p:cNvSpPr txBox="1"/>
              <p:nvPr/>
            </p:nvSpPr>
            <p:spPr>
              <a:xfrm>
                <a:off x="7121741" y="2647242"/>
                <a:ext cx="41616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   T</a:t>
                </a:r>
              </a:p>
            </p:txBody>
          </p:sp>
        </p:grp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9F2F4DA8-D3B9-AD4E-8920-564178934BFD}"/>
              </a:ext>
            </a:extLst>
          </p:cNvPr>
          <p:cNvGrpSpPr/>
          <p:nvPr/>
        </p:nvGrpSpPr>
        <p:grpSpPr>
          <a:xfrm>
            <a:off x="7540841" y="2643432"/>
            <a:ext cx="416169" cy="215444"/>
            <a:chOff x="7121741" y="2647242"/>
            <a:chExt cx="416169" cy="215444"/>
          </a:xfrm>
        </p:grpSpPr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701D17D8-ED6E-F041-852A-4BEC2AECC0FF}"/>
                </a:ext>
              </a:extLst>
            </p:cNvPr>
            <p:cNvSpPr/>
            <p:nvPr/>
          </p:nvSpPr>
          <p:spPr>
            <a:xfrm>
              <a:off x="7250682" y="2733470"/>
              <a:ext cx="111382" cy="45719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0ADE91B-1092-6649-9A73-535EFDEB211C}"/>
                </a:ext>
              </a:extLst>
            </p:cNvPr>
            <p:cNvSpPr txBox="1"/>
            <p:nvPr/>
          </p:nvSpPr>
          <p:spPr>
            <a:xfrm>
              <a:off x="7121741" y="2647242"/>
              <a:ext cx="4161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   U</a:t>
              </a:r>
            </a:p>
          </p:txBody>
        </p: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2F776EAD-BC1F-D046-9F5A-23B89F8A9D9A}"/>
              </a:ext>
            </a:extLst>
          </p:cNvPr>
          <p:cNvGrpSpPr/>
          <p:nvPr/>
        </p:nvGrpSpPr>
        <p:grpSpPr>
          <a:xfrm>
            <a:off x="6751702" y="2207632"/>
            <a:ext cx="825025" cy="223064"/>
            <a:chOff x="6922435" y="2639622"/>
            <a:chExt cx="825025" cy="223064"/>
          </a:xfrm>
        </p:grpSpPr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EB772E45-CC4E-7F4D-9D94-E76E56C41EB1}"/>
                </a:ext>
              </a:extLst>
            </p:cNvPr>
            <p:cNvGrpSpPr/>
            <p:nvPr/>
          </p:nvGrpSpPr>
          <p:grpSpPr>
            <a:xfrm>
              <a:off x="6922435" y="2641381"/>
              <a:ext cx="416169" cy="215444"/>
              <a:chOff x="8094755" y="2406918"/>
              <a:chExt cx="416169" cy="215444"/>
            </a:xfrm>
          </p:grpSpPr>
          <p:sp>
            <p:nvSpPr>
              <p:cNvPr id="37" name="Rectangle 36">
                <a:extLst>
                  <a:ext uri="{FF2B5EF4-FFF2-40B4-BE49-F238E27FC236}">
                    <a16:creationId xmlns:a16="http://schemas.microsoft.com/office/drawing/2014/main" id="{9F230979-37B2-DE43-A7B0-EE279C5EA688}"/>
                  </a:ext>
                </a:extLst>
              </p:cNvPr>
              <p:cNvSpPr/>
              <p:nvPr/>
            </p:nvSpPr>
            <p:spPr>
              <a:xfrm>
                <a:off x="8182679" y="2493147"/>
                <a:ext cx="240323" cy="45719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D9915984-C561-314D-A682-54479A4EB6C4}"/>
                  </a:ext>
                </a:extLst>
              </p:cNvPr>
              <p:cNvSpPr txBox="1"/>
              <p:nvPr/>
            </p:nvSpPr>
            <p:spPr>
              <a:xfrm>
                <a:off x="8094755" y="2406918"/>
                <a:ext cx="41616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err="1"/>
                  <a:t>ssaQ</a:t>
                </a:r>
                <a:endParaRPr lang="en-US" sz="800" dirty="0"/>
              </a:p>
            </p:txBody>
          </p:sp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FCBF7B3A-8AD5-FB4E-814B-DB1279048E87}"/>
                </a:ext>
              </a:extLst>
            </p:cNvPr>
            <p:cNvGrpSpPr/>
            <p:nvPr/>
          </p:nvGrpSpPr>
          <p:grpSpPr>
            <a:xfrm>
              <a:off x="7121741" y="2647242"/>
              <a:ext cx="416169" cy="215444"/>
              <a:chOff x="7121741" y="2647242"/>
              <a:chExt cx="416169" cy="215444"/>
            </a:xfrm>
          </p:grpSpPr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0F042823-8F2D-BD45-914B-F2814CD48838}"/>
                  </a:ext>
                </a:extLst>
              </p:cNvPr>
              <p:cNvSpPr/>
              <p:nvPr/>
            </p:nvSpPr>
            <p:spPr>
              <a:xfrm>
                <a:off x="7250682" y="2733470"/>
                <a:ext cx="111382" cy="45719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B345DF7C-7CE6-594C-8341-CF6EADBE718A}"/>
                  </a:ext>
                </a:extLst>
              </p:cNvPr>
              <p:cNvSpPr txBox="1"/>
              <p:nvPr/>
            </p:nvSpPr>
            <p:spPr>
              <a:xfrm>
                <a:off x="7121741" y="2647242"/>
                <a:ext cx="41616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   R</a:t>
                </a:r>
              </a:p>
            </p:txBody>
          </p:sp>
        </p:grp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BCC7B828-7908-9B44-97DA-2CCDE16BDABA}"/>
                </a:ext>
              </a:extLst>
            </p:cNvPr>
            <p:cNvGrpSpPr/>
            <p:nvPr/>
          </p:nvGrpSpPr>
          <p:grpSpPr>
            <a:xfrm>
              <a:off x="7331291" y="2639622"/>
              <a:ext cx="416169" cy="215444"/>
              <a:chOff x="7121741" y="2647242"/>
              <a:chExt cx="416169" cy="215444"/>
            </a:xfrm>
          </p:grpSpPr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49999E74-F36F-5945-A3C5-279853255182}"/>
                  </a:ext>
                </a:extLst>
              </p:cNvPr>
              <p:cNvSpPr/>
              <p:nvPr/>
            </p:nvSpPr>
            <p:spPr>
              <a:xfrm>
                <a:off x="7250682" y="2733470"/>
                <a:ext cx="111382" cy="45719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66867955-37EC-F647-B19E-22362CF246D9}"/>
                  </a:ext>
                </a:extLst>
              </p:cNvPr>
              <p:cNvSpPr txBox="1"/>
              <p:nvPr/>
            </p:nvSpPr>
            <p:spPr>
              <a:xfrm>
                <a:off x="7121741" y="2647242"/>
                <a:ext cx="41616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   T</a:t>
                </a:r>
              </a:p>
            </p:txBody>
          </p:sp>
        </p:grp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089FE6B7-E721-9D4D-B299-8CA4CF1F690D}"/>
              </a:ext>
            </a:extLst>
          </p:cNvPr>
          <p:cNvGrpSpPr/>
          <p:nvPr/>
        </p:nvGrpSpPr>
        <p:grpSpPr>
          <a:xfrm>
            <a:off x="6009600" y="3060154"/>
            <a:ext cx="825025" cy="223064"/>
            <a:chOff x="6922435" y="2639622"/>
            <a:chExt cx="825025" cy="223064"/>
          </a:xfrm>
        </p:grpSpPr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FA92FB75-4556-BF4D-83F2-2824F6DE33E8}"/>
                </a:ext>
              </a:extLst>
            </p:cNvPr>
            <p:cNvGrpSpPr/>
            <p:nvPr/>
          </p:nvGrpSpPr>
          <p:grpSpPr>
            <a:xfrm>
              <a:off x="6922435" y="2641381"/>
              <a:ext cx="416169" cy="215444"/>
              <a:chOff x="8094755" y="2406918"/>
              <a:chExt cx="416169" cy="215444"/>
            </a:xfrm>
          </p:grpSpPr>
          <p:sp>
            <p:nvSpPr>
              <p:cNvPr id="47" name="Rectangle 46">
                <a:extLst>
                  <a:ext uri="{FF2B5EF4-FFF2-40B4-BE49-F238E27FC236}">
                    <a16:creationId xmlns:a16="http://schemas.microsoft.com/office/drawing/2014/main" id="{04DD8DFF-9469-6C40-BEF2-B13146E7A04E}"/>
                  </a:ext>
                </a:extLst>
              </p:cNvPr>
              <p:cNvSpPr/>
              <p:nvPr/>
            </p:nvSpPr>
            <p:spPr>
              <a:xfrm>
                <a:off x="8182679" y="2493147"/>
                <a:ext cx="240323" cy="45719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17B00F57-B06E-464D-B6EF-E4CA9401ADF5}"/>
                  </a:ext>
                </a:extLst>
              </p:cNvPr>
              <p:cNvSpPr txBox="1"/>
              <p:nvPr/>
            </p:nvSpPr>
            <p:spPr>
              <a:xfrm>
                <a:off x="8094755" y="2406918"/>
                <a:ext cx="41616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err="1"/>
                  <a:t>ssaQ</a:t>
                </a:r>
                <a:endParaRPr lang="en-US" sz="800" dirty="0"/>
              </a:p>
            </p:txBody>
          </p:sp>
        </p:grpSp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FCF75E91-F0AC-2541-9394-2C920396703F}"/>
                </a:ext>
              </a:extLst>
            </p:cNvPr>
            <p:cNvGrpSpPr/>
            <p:nvPr/>
          </p:nvGrpSpPr>
          <p:grpSpPr>
            <a:xfrm>
              <a:off x="7121741" y="2647242"/>
              <a:ext cx="416169" cy="215444"/>
              <a:chOff x="7121741" y="2647242"/>
              <a:chExt cx="416169" cy="215444"/>
            </a:xfrm>
          </p:grpSpPr>
          <p:sp>
            <p:nvSpPr>
              <p:cNvPr id="45" name="Rectangle 44">
                <a:extLst>
                  <a:ext uri="{FF2B5EF4-FFF2-40B4-BE49-F238E27FC236}">
                    <a16:creationId xmlns:a16="http://schemas.microsoft.com/office/drawing/2014/main" id="{DA8F3FD6-6F91-E242-A2EB-A57B4BB3836C}"/>
                  </a:ext>
                </a:extLst>
              </p:cNvPr>
              <p:cNvSpPr/>
              <p:nvPr/>
            </p:nvSpPr>
            <p:spPr>
              <a:xfrm>
                <a:off x="7250682" y="2733470"/>
                <a:ext cx="111382" cy="45719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DA49A490-CBEA-B342-BC39-F0628DA1D11C}"/>
                  </a:ext>
                </a:extLst>
              </p:cNvPr>
              <p:cNvSpPr txBox="1"/>
              <p:nvPr/>
            </p:nvSpPr>
            <p:spPr>
              <a:xfrm>
                <a:off x="7121741" y="2647242"/>
                <a:ext cx="41616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   R</a:t>
                </a:r>
              </a:p>
            </p:txBody>
          </p:sp>
        </p:grpSp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37FE2D3B-9EB1-AD4C-8E54-1A566505B1CC}"/>
                </a:ext>
              </a:extLst>
            </p:cNvPr>
            <p:cNvGrpSpPr/>
            <p:nvPr/>
          </p:nvGrpSpPr>
          <p:grpSpPr>
            <a:xfrm>
              <a:off x="7331291" y="2639622"/>
              <a:ext cx="416169" cy="215444"/>
              <a:chOff x="7121741" y="2647242"/>
              <a:chExt cx="416169" cy="215444"/>
            </a:xfrm>
          </p:grpSpPr>
          <p:sp>
            <p:nvSpPr>
              <p:cNvPr id="43" name="Rectangle 42">
                <a:extLst>
                  <a:ext uri="{FF2B5EF4-FFF2-40B4-BE49-F238E27FC236}">
                    <a16:creationId xmlns:a16="http://schemas.microsoft.com/office/drawing/2014/main" id="{C4F1AEE1-88DE-C040-BD03-F3026BD14B4A}"/>
                  </a:ext>
                </a:extLst>
              </p:cNvPr>
              <p:cNvSpPr/>
              <p:nvPr/>
            </p:nvSpPr>
            <p:spPr>
              <a:xfrm>
                <a:off x="7250682" y="2733470"/>
                <a:ext cx="111382" cy="45719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0E392916-7EAF-C048-97B1-1B7CA12BDDEC}"/>
                  </a:ext>
                </a:extLst>
              </p:cNvPr>
              <p:cNvSpPr txBox="1"/>
              <p:nvPr/>
            </p:nvSpPr>
            <p:spPr>
              <a:xfrm>
                <a:off x="7121741" y="2647242"/>
                <a:ext cx="41616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   T</a:t>
                </a:r>
              </a:p>
            </p:txBody>
          </p:sp>
        </p:grpSp>
      </p:grpSp>
      <p:sp>
        <p:nvSpPr>
          <p:cNvPr id="53" name="Rectangle 52">
            <a:extLst>
              <a:ext uri="{FF2B5EF4-FFF2-40B4-BE49-F238E27FC236}">
                <a16:creationId xmlns:a16="http://schemas.microsoft.com/office/drawing/2014/main" id="{94125508-C1CD-AA49-AF00-DF43E9F3E133}"/>
              </a:ext>
            </a:extLst>
          </p:cNvPr>
          <p:cNvSpPr/>
          <p:nvPr/>
        </p:nvSpPr>
        <p:spPr>
          <a:xfrm>
            <a:off x="1906215" y="2726998"/>
            <a:ext cx="111382" cy="45719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57A2D8B1-8D69-8B4C-818A-3F2FC5404529}"/>
              </a:ext>
            </a:extLst>
          </p:cNvPr>
          <p:cNvSpPr/>
          <p:nvPr/>
        </p:nvSpPr>
        <p:spPr>
          <a:xfrm>
            <a:off x="4004294" y="3587542"/>
            <a:ext cx="111382" cy="45719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C92E025D-AAA1-DC44-90B8-5A64A5CCE33E}"/>
              </a:ext>
            </a:extLst>
          </p:cNvPr>
          <p:cNvSpPr/>
          <p:nvPr/>
        </p:nvSpPr>
        <p:spPr>
          <a:xfrm>
            <a:off x="4466077" y="3581816"/>
            <a:ext cx="164735" cy="53742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55F6138C-3A12-9242-AB88-5D4EFE11696B}"/>
              </a:ext>
            </a:extLst>
          </p:cNvPr>
          <p:cNvSpPr/>
          <p:nvPr/>
        </p:nvSpPr>
        <p:spPr>
          <a:xfrm>
            <a:off x="4730129" y="3581817"/>
            <a:ext cx="164735" cy="53742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C34A2D68-3329-5A45-A318-3BAFF7566B2D}"/>
              </a:ext>
            </a:extLst>
          </p:cNvPr>
          <p:cNvSpPr/>
          <p:nvPr/>
        </p:nvSpPr>
        <p:spPr>
          <a:xfrm>
            <a:off x="3456855" y="3859857"/>
            <a:ext cx="164735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2F92442B-730B-2D43-B735-E06970201F58}"/>
              </a:ext>
            </a:extLst>
          </p:cNvPr>
          <p:cNvSpPr/>
          <p:nvPr/>
        </p:nvSpPr>
        <p:spPr>
          <a:xfrm>
            <a:off x="5928701" y="3861005"/>
            <a:ext cx="164735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788C2DC9-478C-324C-871F-C1A39DB24CE6}"/>
              </a:ext>
            </a:extLst>
          </p:cNvPr>
          <p:cNvSpPr/>
          <p:nvPr/>
        </p:nvSpPr>
        <p:spPr>
          <a:xfrm>
            <a:off x="7062961" y="3859751"/>
            <a:ext cx="164735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1ED7DAEA-211F-9F4D-B8B2-E391CB36CE86}"/>
              </a:ext>
            </a:extLst>
          </p:cNvPr>
          <p:cNvSpPr/>
          <p:nvPr/>
        </p:nvSpPr>
        <p:spPr>
          <a:xfrm>
            <a:off x="7938645" y="3858497"/>
            <a:ext cx="164735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75D7A6E2-0F48-984B-B8EA-7B761F203E60}"/>
              </a:ext>
            </a:extLst>
          </p:cNvPr>
          <p:cNvSpPr/>
          <p:nvPr/>
        </p:nvSpPr>
        <p:spPr>
          <a:xfrm>
            <a:off x="6039112" y="4715435"/>
            <a:ext cx="164735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8493BDF5-8FC0-CA4A-B7CD-1FCE6719F8D8}"/>
              </a:ext>
            </a:extLst>
          </p:cNvPr>
          <p:cNvSpPr/>
          <p:nvPr/>
        </p:nvSpPr>
        <p:spPr>
          <a:xfrm>
            <a:off x="5768024" y="5145157"/>
            <a:ext cx="164735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7E9E4EDA-F84D-9D41-83E5-CBA2B7A6E740}"/>
              </a:ext>
            </a:extLst>
          </p:cNvPr>
          <p:cNvSpPr/>
          <p:nvPr/>
        </p:nvSpPr>
        <p:spPr>
          <a:xfrm>
            <a:off x="6939750" y="5143901"/>
            <a:ext cx="164735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1B9DAF8F-3836-034F-BD7B-40AA6853F479}"/>
              </a:ext>
            </a:extLst>
          </p:cNvPr>
          <p:cNvSpPr/>
          <p:nvPr/>
        </p:nvSpPr>
        <p:spPr>
          <a:xfrm>
            <a:off x="3717522" y="5570679"/>
            <a:ext cx="4802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F7BDD418-0F4A-0148-B27D-A93F3D4EA9BF}"/>
              </a:ext>
            </a:extLst>
          </p:cNvPr>
          <p:cNvSpPr/>
          <p:nvPr/>
        </p:nvSpPr>
        <p:spPr>
          <a:xfrm>
            <a:off x="2859690" y="6005654"/>
            <a:ext cx="4802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500E887A-049F-C846-83A7-522D75F3D660}"/>
              </a:ext>
            </a:extLst>
          </p:cNvPr>
          <p:cNvSpPr/>
          <p:nvPr/>
        </p:nvSpPr>
        <p:spPr>
          <a:xfrm>
            <a:off x="9407564" y="5143901"/>
            <a:ext cx="164735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31E66526-6F2D-C44D-AE5F-E6930DF3DAEF}"/>
              </a:ext>
            </a:extLst>
          </p:cNvPr>
          <p:cNvSpPr/>
          <p:nvPr/>
        </p:nvSpPr>
        <p:spPr>
          <a:xfrm>
            <a:off x="10564986" y="5143901"/>
            <a:ext cx="4802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5F83673D-1F03-D946-BFCB-5F831CF83A7D}"/>
              </a:ext>
            </a:extLst>
          </p:cNvPr>
          <p:cNvSpPr/>
          <p:nvPr/>
        </p:nvSpPr>
        <p:spPr>
          <a:xfrm>
            <a:off x="2422128" y="4718610"/>
            <a:ext cx="164735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F539E18F-3B32-9345-9FF9-2CD47D7B9160}"/>
              </a:ext>
            </a:extLst>
          </p:cNvPr>
          <p:cNvSpPr/>
          <p:nvPr/>
        </p:nvSpPr>
        <p:spPr>
          <a:xfrm>
            <a:off x="3595812" y="4715435"/>
            <a:ext cx="164735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BEA48D6D-885B-AB4E-8E25-12C262683201}"/>
              </a:ext>
            </a:extLst>
          </p:cNvPr>
          <p:cNvSpPr/>
          <p:nvPr/>
        </p:nvSpPr>
        <p:spPr>
          <a:xfrm>
            <a:off x="2561463" y="5570679"/>
            <a:ext cx="164735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CA1F7C74-2D23-AB41-8FE1-D2435D44D433}"/>
              </a:ext>
            </a:extLst>
          </p:cNvPr>
          <p:cNvSpPr/>
          <p:nvPr/>
        </p:nvSpPr>
        <p:spPr>
          <a:xfrm>
            <a:off x="2238772" y="5147076"/>
            <a:ext cx="164735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4CD7B614-D48B-3444-9CDE-B98128DB401D}"/>
              </a:ext>
            </a:extLst>
          </p:cNvPr>
          <p:cNvSpPr/>
          <p:nvPr/>
        </p:nvSpPr>
        <p:spPr>
          <a:xfrm>
            <a:off x="1899047" y="6001151"/>
            <a:ext cx="164735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54BED270-C680-5B40-A4A9-C619CB4FBB20}"/>
              </a:ext>
            </a:extLst>
          </p:cNvPr>
          <p:cNvSpPr/>
          <p:nvPr/>
        </p:nvSpPr>
        <p:spPr>
          <a:xfrm>
            <a:off x="3899667" y="4290797"/>
            <a:ext cx="164735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074FECC8-5C68-4940-9BB2-C7F68CB9280F}"/>
              </a:ext>
            </a:extLst>
          </p:cNvPr>
          <p:cNvSpPr/>
          <p:nvPr/>
        </p:nvSpPr>
        <p:spPr>
          <a:xfrm>
            <a:off x="9702800" y="5143901"/>
            <a:ext cx="133241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2FF51ADC-EDE6-6A44-9D12-AA32C139DAEB}"/>
              </a:ext>
            </a:extLst>
          </p:cNvPr>
          <p:cNvSpPr/>
          <p:nvPr/>
        </p:nvSpPr>
        <p:spPr>
          <a:xfrm>
            <a:off x="9855200" y="5296301"/>
            <a:ext cx="133241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8F2A5CD5-A2BA-3544-97A7-A32B1F67F9A5}"/>
              </a:ext>
            </a:extLst>
          </p:cNvPr>
          <p:cNvSpPr/>
          <p:nvPr/>
        </p:nvSpPr>
        <p:spPr>
          <a:xfrm>
            <a:off x="4890923" y="2733732"/>
            <a:ext cx="79157" cy="45719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499A96EC-EA3A-5F49-A36D-FEE2D3F75005}"/>
              </a:ext>
            </a:extLst>
          </p:cNvPr>
          <p:cNvSpPr txBox="1"/>
          <p:nvPr/>
        </p:nvSpPr>
        <p:spPr>
          <a:xfrm>
            <a:off x="5666430" y="5085150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hypD</a:t>
            </a:r>
            <a:endParaRPr lang="en-US" sz="700" dirty="0"/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4FEE07E7-3CEE-3F44-8E65-43138D67463B}"/>
              </a:ext>
            </a:extLst>
          </p:cNvPr>
          <p:cNvSpPr txBox="1"/>
          <p:nvPr/>
        </p:nvSpPr>
        <p:spPr>
          <a:xfrm>
            <a:off x="5921650" y="5082830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hypE</a:t>
            </a:r>
            <a:endParaRPr lang="en-US" sz="700" dirty="0"/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07A6DC7E-18C2-C64F-87F7-C2B4647EC4A5}"/>
              </a:ext>
            </a:extLst>
          </p:cNvPr>
          <p:cNvSpPr txBox="1"/>
          <p:nvPr/>
        </p:nvSpPr>
        <p:spPr>
          <a:xfrm>
            <a:off x="4311474" y="5082830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hycD</a:t>
            </a:r>
            <a:endParaRPr lang="en-US" sz="700" dirty="0"/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1905072E-0721-AF42-8241-0DA7664BC9B7}"/>
              </a:ext>
            </a:extLst>
          </p:cNvPr>
          <p:cNvSpPr txBox="1"/>
          <p:nvPr/>
        </p:nvSpPr>
        <p:spPr>
          <a:xfrm>
            <a:off x="3350244" y="3806470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prgH</a:t>
            </a:r>
            <a:endParaRPr lang="en-US" sz="700" dirty="0"/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51D8D1D0-16F3-3C4C-A6B2-7F84E30F8C5A}"/>
              </a:ext>
            </a:extLst>
          </p:cNvPr>
          <p:cNvSpPr txBox="1"/>
          <p:nvPr/>
        </p:nvSpPr>
        <p:spPr>
          <a:xfrm>
            <a:off x="3645566" y="3806470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hilD</a:t>
            </a:r>
            <a:endParaRPr lang="en-US" sz="700" dirty="0"/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AC29EA80-C058-8543-97C6-6C1938B3B3EC}"/>
              </a:ext>
            </a:extLst>
          </p:cNvPr>
          <p:cNvSpPr txBox="1"/>
          <p:nvPr/>
        </p:nvSpPr>
        <p:spPr>
          <a:xfrm>
            <a:off x="2996716" y="3930496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prgK</a:t>
            </a:r>
            <a:endParaRPr lang="en-US" sz="700" dirty="0"/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50489153-06D3-E549-8ADE-F26EA4F65ECF}"/>
              </a:ext>
            </a:extLst>
          </p:cNvPr>
          <p:cNvSpPr txBox="1"/>
          <p:nvPr/>
        </p:nvSpPr>
        <p:spPr>
          <a:xfrm>
            <a:off x="2323902" y="3813865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hilC</a:t>
            </a:r>
            <a:endParaRPr lang="en-US" sz="700" dirty="0"/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E464BC85-05E2-1D42-8054-0F0284CE6777}"/>
              </a:ext>
            </a:extLst>
          </p:cNvPr>
          <p:cNvSpPr txBox="1"/>
          <p:nvPr/>
        </p:nvSpPr>
        <p:spPr>
          <a:xfrm>
            <a:off x="2328265" y="4657058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hypD</a:t>
            </a:r>
            <a:endParaRPr lang="en-US" sz="700" dirty="0"/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0C1EF55E-0074-7647-BF91-04A88BEE03CA}"/>
              </a:ext>
            </a:extLst>
          </p:cNvPr>
          <p:cNvSpPr txBox="1"/>
          <p:nvPr/>
        </p:nvSpPr>
        <p:spPr>
          <a:xfrm>
            <a:off x="2583485" y="4654738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hypE</a:t>
            </a:r>
            <a:endParaRPr lang="en-US" sz="700" dirty="0"/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A634F770-F544-F740-BFC5-612E51D036E8}"/>
              </a:ext>
            </a:extLst>
          </p:cNvPr>
          <p:cNvSpPr txBox="1"/>
          <p:nvPr/>
        </p:nvSpPr>
        <p:spPr>
          <a:xfrm>
            <a:off x="2430876" y="5517589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prgH</a:t>
            </a:r>
            <a:endParaRPr lang="en-US" sz="700" dirty="0"/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46457AAB-7F24-DD48-8731-CD76B998E046}"/>
              </a:ext>
            </a:extLst>
          </p:cNvPr>
          <p:cNvSpPr txBox="1"/>
          <p:nvPr/>
        </p:nvSpPr>
        <p:spPr>
          <a:xfrm>
            <a:off x="2726198" y="5517589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hilD</a:t>
            </a:r>
            <a:endParaRPr lang="en-US" sz="700" dirty="0"/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CA91EA47-F4C6-F84B-A5EB-0072E843943B}"/>
              </a:ext>
            </a:extLst>
          </p:cNvPr>
          <p:cNvSpPr txBox="1"/>
          <p:nvPr/>
        </p:nvSpPr>
        <p:spPr>
          <a:xfrm>
            <a:off x="2077348" y="5513865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prgK</a:t>
            </a:r>
            <a:endParaRPr lang="en-US" sz="700" dirty="0"/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3D56FCE2-293F-6842-9905-990CEC73DA13}"/>
              </a:ext>
            </a:extLst>
          </p:cNvPr>
          <p:cNvSpPr txBox="1"/>
          <p:nvPr/>
        </p:nvSpPr>
        <p:spPr>
          <a:xfrm>
            <a:off x="6860607" y="5082830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sitA</a:t>
            </a:r>
            <a:endParaRPr lang="en-US" sz="700" dirty="0"/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3A0F5E30-159C-1E4D-A954-83C77C00AB20}"/>
              </a:ext>
            </a:extLst>
          </p:cNvPr>
          <p:cNvSpPr txBox="1"/>
          <p:nvPr/>
        </p:nvSpPr>
        <p:spPr>
          <a:xfrm>
            <a:off x="3514105" y="4657058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sitA</a:t>
            </a:r>
            <a:endParaRPr lang="en-US" sz="700" dirty="0"/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EE5900EE-9735-8B47-8185-4BE54FEB643F}"/>
              </a:ext>
            </a:extLst>
          </p:cNvPr>
          <p:cNvSpPr txBox="1"/>
          <p:nvPr/>
        </p:nvSpPr>
        <p:spPr>
          <a:xfrm>
            <a:off x="9286285" y="5089554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prgH</a:t>
            </a:r>
            <a:endParaRPr lang="en-US" sz="700" dirty="0"/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D8A16019-0198-474F-8BCA-1879871A66E5}"/>
              </a:ext>
            </a:extLst>
          </p:cNvPr>
          <p:cNvSpPr txBox="1"/>
          <p:nvPr/>
        </p:nvSpPr>
        <p:spPr>
          <a:xfrm>
            <a:off x="9581607" y="5089554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hilD</a:t>
            </a:r>
            <a:endParaRPr lang="en-US" sz="700" dirty="0"/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EB7371F6-2E08-3E4C-8713-79C08EED37A2}"/>
              </a:ext>
            </a:extLst>
          </p:cNvPr>
          <p:cNvSpPr txBox="1"/>
          <p:nvPr/>
        </p:nvSpPr>
        <p:spPr>
          <a:xfrm>
            <a:off x="8932757" y="5213580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prgK</a:t>
            </a:r>
            <a:endParaRPr lang="en-US" sz="700" dirty="0"/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C84EAD6D-1372-854E-8DDA-E1B9EA98C907}"/>
              </a:ext>
            </a:extLst>
          </p:cNvPr>
          <p:cNvSpPr txBox="1"/>
          <p:nvPr/>
        </p:nvSpPr>
        <p:spPr>
          <a:xfrm>
            <a:off x="8259943" y="5096949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hilC</a:t>
            </a:r>
            <a:endParaRPr lang="en-US" sz="700" dirty="0"/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2B1C29C6-D7A2-A146-B8D7-567C61EED3AD}"/>
              </a:ext>
            </a:extLst>
          </p:cNvPr>
          <p:cNvSpPr txBox="1"/>
          <p:nvPr/>
        </p:nvSpPr>
        <p:spPr>
          <a:xfrm>
            <a:off x="3795677" y="4227452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prgH</a:t>
            </a:r>
            <a:endParaRPr lang="en-US" sz="700" dirty="0"/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D5F7CAD7-AD25-2442-B309-2B412142D837}"/>
              </a:ext>
            </a:extLst>
          </p:cNvPr>
          <p:cNvSpPr txBox="1"/>
          <p:nvPr/>
        </p:nvSpPr>
        <p:spPr>
          <a:xfrm>
            <a:off x="3442149" y="4351478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prgK</a:t>
            </a:r>
            <a:endParaRPr lang="en-US" sz="700" dirty="0"/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1E3ED397-AF32-B849-A973-9C3ABBD093AA}"/>
              </a:ext>
            </a:extLst>
          </p:cNvPr>
          <p:cNvSpPr txBox="1"/>
          <p:nvPr/>
        </p:nvSpPr>
        <p:spPr>
          <a:xfrm>
            <a:off x="2769335" y="4234847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hilC</a:t>
            </a:r>
            <a:endParaRPr lang="en-US" sz="700" dirty="0"/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BD0CB3A0-04C2-6640-9AFB-55E3A03DEFD4}"/>
              </a:ext>
            </a:extLst>
          </p:cNvPr>
          <p:cNvSpPr txBox="1"/>
          <p:nvPr/>
        </p:nvSpPr>
        <p:spPr>
          <a:xfrm>
            <a:off x="5950490" y="4654738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prgH</a:t>
            </a:r>
            <a:endParaRPr lang="en-US" sz="700" dirty="0"/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40D9635E-837B-084C-8F3A-1B79A41FA213}"/>
              </a:ext>
            </a:extLst>
          </p:cNvPr>
          <p:cNvSpPr txBox="1"/>
          <p:nvPr/>
        </p:nvSpPr>
        <p:spPr>
          <a:xfrm>
            <a:off x="6245812" y="4654738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hilD</a:t>
            </a:r>
            <a:endParaRPr lang="en-US" sz="700" dirty="0"/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EEF2B9FE-7ABA-6045-8382-51254E691DA4}"/>
              </a:ext>
            </a:extLst>
          </p:cNvPr>
          <p:cNvSpPr txBox="1"/>
          <p:nvPr/>
        </p:nvSpPr>
        <p:spPr>
          <a:xfrm>
            <a:off x="5596962" y="4778764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prgK</a:t>
            </a:r>
            <a:endParaRPr lang="en-US" sz="700" dirty="0"/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1C1F14F7-815C-4E4C-8173-C41199057FD5}"/>
              </a:ext>
            </a:extLst>
          </p:cNvPr>
          <p:cNvSpPr txBox="1"/>
          <p:nvPr/>
        </p:nvSpPr>
        <p:spPr>
          <a:xfrm>
            <a:off x="4924148" y="4662133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hilC</a:t>
            </a:r>
            <a:endParaRPr lang="en-US" sz="700" dirty="0"/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A441A1DD-2CDE-D54D-BA51-CE2ED16F5926}"/>
              </a:ext>
            </a:extLst>
          </p:cNvPr>
          <p:cNvSpPr txBox="1"/>
          <p:nvPr/>
        </p:nvSpPr>
        <p:spPr>
          <a:xfrm>
            <a:off x="1831938" y="5942400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sugR</a:t>
            </a:r>
            <a:endParaRPr lang="en-US" sz="700" dirty="0"/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B118FDE3-3456-5F49-9DB8-7ED12FF2A87E}"/>
              </a:ext>
            </a:extLst>
          </p:cNvPr>
          <p:cNvSpPr txBox="1"/>
          <p:nvPr/>
        </p:nvSpPr>
        <p:spPr>
          <a:xfrm>
            <a:off x="5241489" y="5939822"/>
            <a:ext cx="406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mgtC</a:t>
            </a:r>
            <a:endParaRPr lang="en-US" sz="700" dirty="0"/>
          </a:p>
        </p:txBody>
      </p:sp>
    </p:spTree>
    <p:extLst>
      <p:ext uri="{BB962C8B-B14F-4D97-AF65-F5344CB8AC3E}">
        <p14:creationId xmlns:p14="http://schemas.microsoft.com/office/powerpoint/2010/main" val="39906777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76B9EA92-425F-F547-A752-B49C0E4AA4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5200" y="2353855"/>
            <a:ext cx="10261600" cy="231339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B8F3EBB-FE4E-0C4E-BAC6-1D3D994E6564}"/>
              </a:ext>
            </a:extLst>
          </p:cNvPr>
          <p:cNvSpPr txBox="1"/>
          <p:nvPr/>
        </p:nvSpPr>
        <p:spPr>
          <a:xfrm>
            <a:off x="1689315" y="1235645"/>
            <a:ext cx="91144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2B Fig. </a:t>
            </a:r>
            <a:r>
              <a:rPr lang="en-US" dirty="0"/>
              <a:t>Deletions of various chromosomal regions from laboratory and ATCC14028s isolates</a:t>
            </a:r>
          </a:p>
        </p:txBody>
      </p:sp>
    </p:spTree>
    <p:extLst>
      <p:ext uri="{BB962C8B-B14F-4D97-AF65-F5344CB8AC3E}">
        <p14:creationId xmlns:p14="http://schemas.microsoft.com/office/powerpoint/2010/main" val="35918613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48CDE47C-8DC5-604F-B865-F67F781D56E1}"/>
              </a:ext>
            </a:extLst>
          </p:cNvPr>
          <p:cNvSpPr txBox="1"/>
          <p:nvPr/>
        </p:nvSpPr>
        <p:spPr>
          <a:xfrm>
            <a:off x="1096968" y="1128869"/>
            <a:ext cx="95735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2C Fig</a:t>
            </a:r>
            <a:r>
              <a:rPr lang="en-US" dirty="0"/>
              <a:t>. </a:t>
            </a:r>
            <a:r>
              <a:rPr lang="en-US" dirty="0"/>
              <a:t>Loss of lysogenic bacteriophages </a:t>
            </a:r>
            <a:r>
              <a:rPr lang="en-US" dirty="0" smtClean="0"/>
              <a:t>Gifsy-1 or </a:t>
            </a:r>
            <a:r>
              <a:rPr lang="en-US" dirty="0"/>
              <a:t>Gifsy-3 from natural isolates and ATCC14028s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13A2CB7A-5A8F-A048-9D3C-6131D850A056}"/>
              </a:ext>
            </a:extLst>
          </p:cNvPr>
          <p:cNvSpPr/>
          <p:nvPr/>
        </p:nvSpPr>
        <p:spPr>
          <a:xfrm>
            <a:off x="1744956" y="3418896"/>
            <a:ext cx="4802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 descr="Timeline&#10;&#10;Description automatically generated">
            <a:extLst>
              <a:ext uri="{FF2B5EF4-FFF2-40B4-BE49-F238E27FC236}">
                <a16:creationId xmlns:a16="http://schemas.microsoft.com/office/drawing/2014/main" id="{98C9F50C-9C44-F74E-AB50-F9725A9B78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0214" y="2819400"/>
            <a:ext cx="10187585" cy="16076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73927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3A00DD7-634C-3F46-A370-2814A118CB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5200" y="2725093"/>
            <a:ext cx="10261600" cy="100870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585B78C-39DC-BD45-BE16-0BF7B864CE02}"/>
              </a:ext>
            </a:extLst>
          </p:cNvPr>
          <p:cNvSpPr txBox="1"/>
          <p:nvPr/>
        </p:nvSpPr>
        <p:spPr>
          <a:xfrm>
            <a:off x="1689315" y="681925"/>
            <a:ext cx="81537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2D</a:t>
            </a:r>
            <a:r>
              <a:rPr lang="en-US" dirty="0"/>
              <a:t> </a:t>
            </a:r>
            <a:r>
              <a:rPr lang="en-US" dirty="0" smtClean="0"/>
              <a:t>Fig. </a:t>
            </a:r>
            <a:r>
              <a:rPr lang="en-US" dirty="0" smtClean="0"/>
              <a:t>Loss </a:t>
            </a:r>
            <a:r>
              <a:rPr lang="en-US" dirty="0"/>
              <a:t>of </a:t>
            </a:r>
            <a:r>
              <a:rPr lang="en-US" dirty="0" err="1"/>
              <a:t>pSV</a:t>
            </a:r>
            <a:r>
              <a:rPr lang="en-US" dirty="0"/>
              <a:t> </a:t>
            </a:r>
            <a:r>
              <a:rPr lang="en-US" dirty="0" err="1" smtClean="0"/>
              <a:t>IncFII</a:t>
            </a:r>
            <a:r>
              <a:rPr lang="en-US" dirty="0" smtClean="0"/>
              <a:t> (S) Virulence plasmid from </a:t>
            </a:r>
            <a:r>
              <a:rPr lang="en-US" dirty="0"/>
              <a:t>ATCC14028s </a:t>
            </a:r>
            <a:r>
              <a:rPr lang="en-US" dirty="0" smtClean="0"/>
              <a:t>and natural isolates</a:t>
            </a:r>
            <a:endParaRPr lang="en-US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149DECC7-34D1-F846-AD9C-2AD913421570}"/>
              </a:ext>
            </a:extLst>
          </p:cNvPr>
          <p:cNvSpPr/>
          <p:nvPr/>
        </p:nvSpPr>
        <p:spPr>
          <a:xfrm>
            <a:off x="9227548" y="3238782"/>
            <a:ext cx="125345" cy="52270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AF3864C-791B-FE44-9722-D472390E3C79}"/>
              </a:ext>
            </a:extLst>
          </p:cNvPr>
          <p:cNvSpPr txBox="1"/>
          <p:nvPr/>
        </p:nvSpPr>
        <p:spPr>
          <a:xfrm>
            <a:off x="9112466" y="3177306"/>
            <a:ext cx="3665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traN</a:t>
            </a:r>
            <a:endParaRPr lang="en-US" sz="7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0D4189D-B80A-D540-8B12-CBB7F6BCB44F}"/>
              </a:ext>
            </a:extLst>
          </p:cNvPr>
          <p:cNvSpPr txBox="1"/>
          <p:nvPr/>
        </p:nvSpPr>
        <p:spPr>
          <a:xfrm>
            <a:off x="2603100" y="3321278"/>
            <a:ext cx="4161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/>
              <a:t>pefC</a:t>
            </a:r>
            <a:endParaRPr lang="en-US" sz="8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D624D5D-04A5-3D46-B2F8-77E1E7DF1A59}"/>
              </a:ext>
            </a:extLst>
          </p:cNvPr>
          <p:cNvSpPr txBox="1"/>
          <p:nvPr/>
        </p:nvSpPr>
        <p:spPr>
          <a:xfrm>
            <a:off x="4359641" y="3153919"/>
            <a:ext cx="41616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spvB</a:t>
            </a:r>
            <a:endParaRPr lang="en-US" sz="7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83AD8C5-7E46-3E48-AA72-F397B4E0E6E9}"/>
              </a:ext>
            </a:extLst>
          </p:cNvPr>
          <p:cNvSpPr txBox="1"/>
          <p:nvPr/>
        </p:nvSpPr>
        <p:spPr>
          <a:xfrm>
            <a:off x="10139949" y="3176001"/>
            <a:ext cx="3665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/>
              <a:t>traD</a:t>
            </a:r>
            <a:endParaRPr lang="en-US" sz="700" dirty="0"/>
          </a:p>
        </p:txBody>
      </p:sp>
    </p:spTree>
    <p:extLst>
      <p:ext uri="{BB962C8B-B14F-4D97-AF65-F5344CB8AC3E}">
        <p14:creationId xmlns:p14="http://schemas.microsoft.com/office/powerpoint/2010/main" val="202989570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Background pattern&#10;&#10;Description automatically generated with medium confidence">
            <a:extLst>
              <a:ext uri="{FF2B5EF4-FFF2-40B4-BE49-F238E27FC236}">
                <a16:creationId xmlns:a16="http://schemas.microsoft.com/office/drawing/2014/main" id="{0D5B4235-FA7E-B64D-B832-44C99784D76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5200" y="1957069"/>
            <a:ext cx="10261600" cy="2850061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9CFDCF7F-F240-C049-89B6-15A96D8942D8}"/>
              </a:ext>
            </a:extLst>
          </p:cNvPr>
          <p:cNvSpPr txBox="1"/>
          <p:nvPr/>
        </p:nvSpPr>
        <p:spPr>
          <a:xfrm>
            <a:off x="1689315" y="681925"/>
            <a:ext cx="5627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2E</a:t>
            </a:r>
            <a:r>
              <a:rPr lang="en-US" dirty="0"/>
              <a:t> </a:t>
            </a:r>
            <a:r>
              <a:rPr lang="en-US" dirty="0" smtClean="0"/>
              <a:t>Fig. </a:t>
            </a:r>
            <a:r>
              <a:rPr lang="en-US" dirty="0"/>
              <a:t>Bacteriophages which lysogenized natural </a:t>
            </a:r>
            <a:r>
              <a:rPr lang="en-US" dirty="0" smtClean="0"/>
              <a:t>isolates</a:t>
            </a:r>
            <a:endParaRPr lang="en-US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D5404DD3-6DCA-D340-8544-DFD41AC4D29D}"/>
              </a:ext>
            </a:extLst>
          </p:cNvPr>
          <p:cNvSpPr/>
          <p:nvPr/>
        </p:nvSpPr>
        <p:spPr>
          <a:xfrm>
            <a:off x="4331546" y="3777243"/>
            <a:ext cx="4802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69514EF-1699-9541-8BA9-00C5A92A2B3B}"/>
              </a:ext>
            </a:extLst>
          </p:cNvPr>
          <p:cNvSpPr/>
          <p:nvPr/>
        </p:nvSpPr>
        <p:spPr>
          <a:xfrm>
            <a:off x="5560008" y="3651787"/>
            <a:ext cx="4802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E367D2B-3E88-144D-9C8B-D1F7989A5052}"/>
              </a:ext>
            </a:extLst>
          </p:cNvPr>
          <p:cNvSpPr/>
          <p:nvPr/>
        </p:nvSpPr>
        <p:spPr>
          <a:xfrm>
            <a:off x="7571519" y="3646735"/>
            <a:ext cx="4802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D053D17-4B16-A349-8CC3-D4F778B125EE}"/>
              </a:ext>
            </a:extLst>
          </p:cNvPr>
          <p:cNvSpPr/>
          <p:nvPr/>
        </p:nvSpPr>
        <p:spPr>
          <a:xfrm>
            <a:off x="4414061" y="4082043"/>
            <a:ext cx="4802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635302C6-30F8-B246-AE03-51D2B1CA1B09}"/>
              </a:ext>
            </a:extLst>
          </p:cNvPr>
          <p:cNvSpPr/>
          <p:nvPr/>
        </p:nvSpPr>
        <p:spPr>
          <a:xfrm>
            <a:off x="2344098" y="4208261"/>
            <a:ext cx="108163" cy="7842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72333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imeline&#10;&#10;Description automatically generated">
            <a:extLst>
              <a:ext uri="{FF2B5EF4-FFF2-40B4-BE49-F238E27FC236}">
                <a16:creationId xmlns:a16="http://schemas.microsoft.com/office/drawing/2014/main" id="{E248BF4C-4AD5-C141-9E87-5272CF2C2E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5200" y="2031999"/>
            <a:ext cx="10261600" cy="288858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6E0D0AE-F8E3-334E-8E46-2B8C7D5CEAD4}"/>
              </a:ext>
            </a:extLst>
          </p:cNvPr>
          <p:cNvSpPr txBox="1"/>
          <p:nvPr/>
        </p:nvSpPr>
        <p:spPr>
          <a:xfrm>
            <a:off x="1689315" y="681925"/>
            <a:ext cx="43945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2F</a:t>
            </a:r>
            <a:r>
              <a:rPr lang="en-US" dirty="0"/>
              <a:t> </a:t>
            </a:r>
            <a:r>
              <a:rPr lang="en-US" dirty="0" smtClean="0"/>
              <a:t>Fig. </a:t>
            </a:r>
            <a:r>
              <a:rPr lang="en-US" dirty="0" smtClean="0"/>
              <a:t>Plasmids acquired by natural isolates</a:t>
            </a:r>
            <a:endParaRPr lang="en-US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A7E1C458-6982-4D4F-9809-45022C36DFE0}"/>
              </a:ext>
            </a:extLst>
          </p:cNvPr>
          <p:cNvSpPr/>
          <p:nvPr/>
        </p:nvSpPr>
        <p:spPr>
          <a:xfrm>
            <a:off x="5656836" y="2263347"/>
            <a:ext cx="4802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841924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text, screenshot, lamp&#10;&#10;Description automatically generated">
            <a:extLst>
              <a:ext uri="{FF2B5EF4-FFF2-40B4-BE49-F238E27FC236}">
                <a16:creationId xmlns:a16="http://schemas.microsoft.com/office/drawing/2014/main" id="{F413E227-A76E-234B-B61D-D4E1D777D0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3300" y="1578750"/>
            <a:ext cx="10185400" cy="449112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3D5BE1B-CAB4-7049-B8E9-68605D46B78E}"/>
              </a:ext>
            </a:extLst>
          </p:cNvPr>
          <p:cNvSpPr txBox="1"/>
          <p:nvPr/>
        </p:nvSpPr>
        <p:spPr>
          <a:xfrm>
            <a:off x="1689315" y="681925"/>
            <a:ext cx="6655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2G</a:t>
            </a:r>
            <a:r>
              <a:rPr lang="en-US" dirty="0"/>
              <a:t> </a:t>
            </a:r>
            <a:r>
              <a:rPr lang="en-US" dirty="0" smtClean="0"/>
              <a:t>Fig. </a:t>
            </a:r>
            <a:r>
              <a:rPr lang="en-US" dirty="0" smtClean="0"/>
              <a:t>IncI1 plasmids acquired by natural isolates and lab infections</a:t>
            </a:r>
            <a:endParaRPr lang="en-US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D66AD0A-E245-F849-8E23-E9441278B18C}"/>
              </a:ext>
            </a:extLst>
          </p:cNvPr>
          <p:cNvSpPr/>
          <p:nvPr/>
        </p:nvSpPr>
        <p:spPr>
          <a:xfrm>
            <a:off x="3403674" y="3741758"/>
            <a:ext cx="4802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FCD13D0F-D0A8-AE4C-AC04-B71A68B4025C}"/>
              </a:ext>
            </a:extLst>
          </p:cNvPr>
          <p:cNvSpPr/>
          <p:nvPr/>
        </p:nvSpPr>
        <p:spPr>
          <a:xfrm>
            <a:off x="3101400" y="4182119"/>
            <a:ext cx="4802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4C4ABD9F-435C-DE47-ABD2-B6D8F098324B}"/>
              </a:ext>
            </a:extLst>
          </p:cNvPr>
          <p:cNvSpPr/>
          <p:nvPr/>
        </p:nvSpPr>
        <p:spPr>
          <a:xfrm>
            <a:off x="3101400" y="4750889"/>
            <a:ext cx="4802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1D02D3F-8426-2E4A-B1A5-FBF44EDC926E}"/>
              </a:ext>
            </a:extLst>
          </p:cNvPr>
          <p:cNvSpPr/>
          <p:nvPr/>
        </p:nvSpPr>
        <p:spPr>
          <a:xfrm>
            <a:off x="3577124" y="5329750"/>
            <a:ext cx="4802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34FB1189-4567-1F4A-B75C-B05C1E2DD252}"/>
              </a:ext>
            </a:extLst>
          </p:cNvPr>
          <p:cNvSpPr/>
          <p:nvPr/>
        </p:nvSpPr>
        <p:spPr>
          <a:xfrm>
            <a:off x="3164584" y="5775161"/>
            <a:ext cx="4802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F07E0911-6476-2241-9B5A-2510BC61FD8E}"/>
              </a:ext>
            </a:extLst>
          </p:cNvPr>
          <p:cNvSpPr/>
          <p:nvPr/>
        </p:nvSpPr>
        <p:spPr>
          <a:xfrm>
            <a:off x="5519626" y="5329750"/>
            <a:ext cx="123383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DC07E33F-7A64-774F-9EE3-8DF451B09FA3}"/>
              </a:ext>
            </a:extLst>
          </p:cNvPr>
          <p:cNvSpPr/>
          <p:nvPr/>
        </p:nvSpPr>
        <p:spPr>
          <a:xfrm>
            <a:off x="4883924" y="4750889"/>
            <a:ext cx="123383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8F18E06-13E2-8840-9693-5E500AC4030F}"/>
              </a:ext>
            </a:extLst>
          </p:cNvPr>
          <p:cNvSpPr/>
          <p:nvPr/>
        </p:nvSpPr>
        <p:spPr>
          <a:xfrm>
            <a:off x="5012359" y="4182119"/>
            <a:ext cx="123383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490608A1-FA7F-EF4E-B5C6-5E85F6A92E4F}"/>
              </a:ext>
            </a:extLst>
          </p:cNvPr>
          <p:cNvSpPr/>
          <p:nvPr/>
        </p:nvSpPr>
        <p:spPr>
          <a:xfrm>
            <a:off x="5296110" y="3736706"/>
            <a:ext cx="123383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9227EDBC-9153-0348-936A-A58B3EBF9FC2}"/>
              </a:ext>
            </a:extLst>
          </p:cNvPr>
          <p:cNvSpPr/>
          <p:nvPr/>
        </p:nvSpPr>
        <p:spPr>
          <a:xfrm>
            <a:off x="4932306" y="3298030"/>
            <a:ext cx="123383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3A373AC0-F67E-F94B-8E94-001A7212DD83}"/>
              </a:ext>
            </a:extLst>
          </p:cNvPr>
          <p:cNvSpPr/>
          <p:nvPr/>
        </p:nvSpPr>
        <p:spPr>
          <a:xfrm>
            <a:off x="5296110" y="3741758"/>
            <a:ext cx="123383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7BB2C2EB-487C-2E4C-A58A-3B47ABFC6FBD}"/>
              </a:ext>
            </a:extLst>
          </p:cNvPr>
          <p:cNvSpPr/>
          <p:nvPr/>
        </p:nvSpPr>
        <p:spPr>
          <a:xfrm>
            <a:off x="9161681" y="3298030"/>
            <a:ext cx="8335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D1F49AC8-3E2B-E74D-875E-57F81334319D}"/>
              </a:ext>
            </a:extLst>
          </p:cNvPr>
          <p:cNvSpPr/>
          <p:nvPr/>
        </p:nvSpPr>
        <p:spPr>
          <a:xfrm>
            <a:off x="9521213" y="3293818"/>
            <a:ext cx="8335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BD141C4D-C09F-894D-BE39-BE5B83794C08}"/>
              </a:ext>
            </a:extLst>
          </p:cNvPr>
          <p:cNvSpPr/>
          <p:nvPr/>
        </p:nvSpPr>
        <p:spPr>
          <a:xfrm>
            <a:off x="9789809" y="4173701"/>
            <a:ext cx="8335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51206CD8-91B2-574D-B10B-0C77B506C40A}"/>
              </a:ext>
            </a:extLst>
          </p:cNvPr>
          <p:cNvSpPr/>
          <p:nvPr/>
        </p:nvSpPr>
        <p:spPr>
          <a:xfrm>
            <a:off x="10139237" y="4174541"/>
            <a:ext cx="8335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027B91C9-CEE2-1E4B-8C52-F9D35BAF5C90}"/>
              </a:ext>
            </a:extLst>
          </p:cNvPr>
          <p:cNvSpPr/>
          <p:nvPr/>
        </p:nvSpPr>
        <p:spPr>
          <a:xfrm>
            <a:off x="10114817" y="3735860"/>
            <a:ext cx="8335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978DA44E-4F00-CC40-9D21-A6C4F3F81F9E}"/>
              </a:ext>
            </a:extLst>
          </p:cNvPr>
          <p:cNvSpPr/>
          <p:nvPr/>
        </p:nvSpPr>
        <p:spPr>
          <a:xfrm>
            <a:off x="10469297" y="3731648"/>
            <a:ext cx="8335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5FE91274-FCBE-7E49-B667-3C875CECD9EE}"/>
              </a:ext>
            </a:extLst>
          </p:cNvPr>
          <p:cNvSpPr/>
          <p:nvPr/>
        </p:nvSpPr>
        <p:spPr>
          <a:xfrm>
            <a:off x="10241957" y="4752144"/>
            <a:ext cx="8335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06F91680-EE8C-7A45-89DB-5CE9D76674A8}"/>
              </a:ext>
            </a:extLst>
          </p:cNvPr>
          <p:cNvSpPr/>
          <p:nvPr/>
        </p:nvSpPr>
        <p:spPr>
          <a:xfrm>
            <a:off x="10596437" y="4747932"/>
            <a:ext cx="8335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D75A9D2-7B41-DF4B-93BE-0458E6AA92AC}"/>
              </a:ext>
            </a:extLst>
          </p:cNvPr>
          <p:cNvSpPr/>
          <p:nvPr/>
        </p:nvSpPr>
        <p:spPr>
          <a:xfrm>
            <a:off x="9737602" y="5328912"/>
            <a:ext cx="8335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F77DE99A-B4EF-A54A-A1CA-AF28CA739A76}"/>
              </a:ext>
            </a:extLst>
          </p:cNvPr>
          <p:cNvSpPr/>
          <p:nvPr/>
        </p:nvSpPr>
        <p:spPr>
          <a:xfrm>
            <a:off x="10092082" y="5324700"/>
            <a:ext cx="8335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CF1F3A73-A847-1547-87AC-41E23FD908DF}"/>
              </a:ext>
            </a:extLst>
          </p:cNvPr>
          <p:cNvSpPr/>
          <p:nvPr/>
        </p:nvSpPr>
        <p:spPr>
          <a:xfrm>
            <a:off x="8849303" y="5774328"/>
            <a:ext cx="8335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7E2E9D68-EEA4-9847-95FF-350179F5A96F}"/>
              </a:ext>
            </a:extLst>
          </p:cNvPr>
          <p:cNvSpPr/>
          <p:nvPr/>
        </p:nvSpPr>
        <p:spPr>
          <a:xfrm>
            <a:off x="9203783" y="5770116"/>
            <a:ext cx="8335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72812194-F437-FE49-951E-E023A734DC6D}"/>
              </a:ext>
            </a:extLst>
          </p:cNvPr>
          <p:cNvSpPr/>
          <p:nvPr/>
        </p:nvSpPr>
        <p:spPr>
          <a:xfrm>
            <a:off x="10217543" y="2715458"/>
            <a:ext cx="8335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99662BCB-5C93-D84D-8150-538CD2845C0B}"/>
              </a:ext>
            </a:extLst>
          </p:cNvPr>
          <p:cNvSpPr/>
          <p:nvPr/>
        </p:nvSpPr>
        <p:spPr>
          <a:xfrm>
            <a:off x="10572023" y="2711246"/>
            <a:ext cx="8335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5FE8EFC8-E80C-F340-B9B4-E4F318C3BCCB}"/>
              </a:ext>
            </a:extLst>
          </p:cNvPr>
          <p:cNvSpPr/>
          <p:nvPr/>
        </p:nvSpPr>
        <p:spPr>
          <a:xfrm>
            <a:off x="9020227" y="1838021"/>
            <a:ext cx="123383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28B06DFD-2922-CA4B-99B6-DF19BBAE4C69}"/>
              </a:ext>
            </a:extLst>
          </p:cNvPr>
          <p:cNvSpPr/>
          <p:nvPr/>
        </p:nvSpPr>
        <p:spPr>
          <a:xfrm>
            <a:off x="9645794" y="2273330"/>
            <a:ext cx="123383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EF5A5035-728D-F14E-B260-2C4E3C54B3D6}"/>
              </a:ext>
            </a:extLst>
          </p:cNvPr>
          <p:cNvSpPr/>
          <p:nvPr/>
        </p:nvSpPr>
        <p:spPr>
          <a:xfrm>
            <a:off x="3980436" y="2711246"/>
            <a:ext cx="4802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D7621E18-F28A-6E4A-B91E-89AE4CEA15E1}"/>
              </a:ext>
            </a:extLst>
          </p:cNvPr>
          <p:cNvSpPr/>
          <p:nvPr/>
        </p:nvSpPr>
        <p:spPr>
          <a:xfrm>
            <a:off x="7694450" y="2273330"/>
            <a:ext cx="4802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422DD282-380C-744C-A4A1-300F92C19BC0}"/>
              </a:ext>
            </a:extLst>
          </p:cNvPr>
          <p:cNvSpPr/>
          <p:nvPr/>
        </p:nvSpPr>
        <p:spPr>
          <a:xfrm>
            <a:off x="6998125" y="1838021"/>
            <a:ext cx="48028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33E6180A-929F-CF49-B65E-28E0C145F51B}"/>
              </a:ext>
            </a:extLst>
          </p:cNvPr>
          <p:cNvSpPr/>
          <p:nvPr/>
        </p:nvSpPr>
        <p:spPr>
          <a:xfrm>
            <a:off x="4820740" y="1838021"/>
            <a:ext cx="96410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093A8B5B-F1A2-8C40-ADB3-5AEFF4837E97}"/>
              </a:ext>
            </a:extLst>
          </p:cNvPr>
          <p:cNvSpPr/>
          <p:nvPr/>
        </p:nvSpPr>
        <p:spPr>
          <a:xfrm>
            <a:off x="4462895" y="1838021"/>
            <a:ext cx="96410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776BC133-C8FD-B54F-A6A5-38E1B19C0BCB}"/>
              </a:ext>
            </a:extLst>
          </p:cNvPr>
          <p:cNvSpPr/>
          <p:nvPr/>
        </p:nvSpPr>
        <p:spPr>
          <a:xfrm>
            <a:off x="5584700" y="2273330"/>
            <a:ext cx="96410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1592AA26-3D36-D541-94BA-583C650D7B10}"/>
              </a:ext>
            </a:extLst>
          </p:cNvPr>
          <p:cNvSpPr/>
          <p:nvPr/>
        </p:nvSpPr>
        <p:spPr>
          <a:xfrm>
            <a:off x="5236959" y="2273330"/>
            <a:ext cx="96410" cy="82554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22004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88</TotalTime>
  <Words>270</Words>
  <Application>Microsoft Office PowerPoint</Application>
  <PresentationFormat>Widescreen</PresentationFormat>
  <Paragraphs>67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S2 Fig. Powerpoint summary of genetic content of genomic islands that were lost and gained within HC20_373.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ker, Craig - ARS</dc:creator>
  <cp:lastModifiedBy>Mark Achtman</cp:lastModifiedBy>
  <cp:revision>41</cp:revision>
  <dcterms:created xsi:type="dcterms:W3CDTF">2020-12-24T00:25:10Z</dcterms:created>
  <dcterms:modified xsi:type="dcterms:W3CDTF">2021-09-15T19:10:49Z</dcterms:modified>
</cp:coreProperties>
</file>